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32" r:id="rId1"/>
  </p:sldMasterIdLst>
  <p:notesMasterIdLst>
    <p:notesMasterId r:id="rId4"/>
  </p:notesMasterIdLst>
  <p:sldIdLst>
    <p:sldId id="455" r:id="rId2"/>
    <p:sldId id="456" r:id="rId3"/>
  </p:sldIdLst>
  <p:sldSz cx="6408738" cy="7559675"/>
  <p:notesSz cx="6858000" cy="99456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81" userDrawn="1">
          <p15:clr>
            <a:srgbClr val="A4A3A4"/>
          </p15:clr>
        </p15:guide>
        <p15:guide id="2" pos="2019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Hye In" initials="A" lastIdx="0" clrIdx="0">
    <p:extLst>
      <p:ext uri="{19B8F6BF-5375-455C-9EA6-DF929625EA0E}">
        <p15:presenceInfo xmlns:p15="http://schemas.microsoft.com/office/powerpoint/2012/main" userId="Hye In" providerId="None"/>
      </p:ext>
    </p:extLst>
  </p:cmAuthor>
  <p:cmAuthor id="2" name="가혜인" initials="가" lastIdx="1" clrIdx="1">
    <p:extLst>
      <p:ext uri="{19B8F6BF-5375-455C-9EA6-DF929625EA0E}">
        <p15:presenceInfo xmlns:p15="http://schemas.microsoft.com/office/powerpoint/2012/main" userId="가혜인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9F739"/>
    <a:srgbClr val="E6E6E6"/>
    <a:srgbClr val="A00499"/>
    <a:srgbClr val="FED6F6"/>
    <a:srgbClr val="F96BDB"/>
    <a:srgbClr val="FD99F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845" autoAdjust="0"/>
    <p:restoredTop sz="94764" autoAdjust="0"/>
  </p:normalViewPr>
  <p:slideViewPr>
    <p:cSldViewPr snapToGrid="0" snapToObjects="1">
      <p:cViewPr>
        <p:scale>
          <a:sx n="75" d="100"/>
          <a:sy n="75" d="100"/>
        </p:scale>
        <p:origin x="3384" y="558"/>
      </p:cViewPr>
      <p:guideLst>
        <p:guide orient="horz" pos="2381"/>
        <p:guide pos="2019"/>
      </p:guideLst>
    </p:cSldViewPr>
  </p:slideViewPr>
  <p:notesTextViewPr>
    <p:cViewPr>
      <p:scale>
        <a:sx n="125" d="100"/>
        <a:sy n="125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45005" cy="4500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17" y="9"/>
            <a:ext cx="2971800" cy="499013"/>
          </a:xfrm>
          <a:prstGeom prst="rect">
            <a:avLst/>
          </a:prstGeom>
        </p:spPr>
        <p:txBody>
          <a:bodyPr vert="horz" lIns="92017" tIns="46009" rIns="92017" bIns="46009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27" y="9"/>
            <a:ext cx="2971800" cy="499013"/>
          </a:xfrm>
          <a:prstGeom prst="rect">
            <a:avLst/>
          </a:prstGeom>
        </p:spPr>
        <p:txBody>
          <a:bodyPr vert="horz" lIns="92017" tIns="46009" rIns="92017" bIns="46009" rtlCol="0"/>
          <a:lstStyle>
            <a:lvl1pPr algn="r">
              <a:defRPr sz="1200"/>
            </a:lvl1pPr>
          </a:lstStyle>
          <a:p>
            <a:fld id="{A29B25EE-5E67-49D0-9324-54015195543F}" type="datetimeFigureOut">
              <a:rPr lang="ko-KR" altLang="en-US" smtClean="0"/>
              <a:t>2021-02-0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005013" y="1241425"/>
            <a:ext cx="2847975" cy="3359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017" tIns="46009" rIns="92017" bIns="46009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1" y="4786367"/>
            <a:ext cx="5486400" cy="3916115"/>
          </a:xfrm>
          <a:prstGeom prst="rect">
            <a:avLst/>
          </a:prstGeom>
        </p:spPr>
        <p:txBody>
          <a:bodyPr vert="horz" lIns="92017" tIns="46009" rIns="92017" bIns="46009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17" y="9446681"/>
            <a:ext cx="2971800" cy="499012"/>
          </a:xfrm>
          <a:prstGeom prst="rect">
            <a:avLst/>
          </a:prstGeom>
        </p:spPr>
        <p:txBody>
          <a:bodyPr vert="horz" lIns="92017" tIns="46009" rIns="92017" bIns="46009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27" y="9446681"/>
            <a:ext cx="2971800" cy="499012"/>
          </a:xfrm>
          <a:prstGeom prst="rect">
            <a:avLst/>
          </a:prstGeom>
        </p:spPr>
        <p:txBody>
          <a:bodyPr vert="horz" lIns="92017" tIns="46009" rIns="92017" bIns="46009" rtlCol="0" anchor="b"/>
          <a:lstStyle>
            <a:lvl1pPr algn="r">
              <a:defRPr sz="1200"/>
            </a:lvl1pPr>
          </a:lstStyle>
          <a:p>
            <a:fld id="{87690746-2C55-4D67-ACF8-62BA61FD8F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722435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598566" rtl="0" eaLnBrk="1" latinLnBrk="1" hangingPunct="1">
      <a:defRPr sz="786" kern="1200">
        <a:solidFill>
          <a:schemeClr val="tx1"/>
        </a:solidFill>
        <a:latin typeface="+mn-lt"/>
        <a:ea typeface="+mn-ea"/>
        <a:cs typeface="+mn-cs"/>
      </a:defRPr>
    </a:lvl1pPr>
    <a:lvl2pPr marL="299283" algn="l" defTabSz="598566" rtl="0" eaLnBrk="1" latinLnBrk="1" hangingPunct="1">
      <a:defRPr sz="786" kern="1200">
        <a:solidFill>
          <a:schemeClr val="tx1"/>
        </a:solidFill>
        <a:latin typeface="+mn-lt"/>
        <a:ea typeface="+mn-ea"/>
        <a:cs typeface="+mn-cs"/>
      </a:defRPr>
    </a:lvl2pPr>
    <a:lvl3pPr marL="598566" algn="l" defTabSz="598566" rtl="0" eaLnBrk="1" latinLnBrk="1" hangingPunct="1">
      <a:defRPr sz="786" kern="1200">
        <a:solidFill>
          <a:schemeClr val="tx1"/>
        </a:solidFill>
        <a:latin typeface="+mn-lt"/>
        <a:ea typeface="+mn-ea"/>
        <a:cs typeface="+mn-cs"/>
      </a:defRPr>
    </a:lvl3pPr>
    <a:lvl4pPr marL="897849" algn="l" defTabSz="598566" rtl="0" eaLnBrk="1" latinLnBrk="1" hangingPunct="1">
      <a:defRPr sz="786" kern="1200">
        <a:solidFill>
          <a:schemeClr val="tx1"/>
        </a:solidFill>
        <a:latin typeface="+mn-lt"/>
        <a:ea typeface="+mn-ea"/>
        <a:cs typeface="+mn-cs"/>
      </a:defRPr>
    </a:lvl4pPr>
    <a:lvl5pPr marL="1197132" algn="l" defTabSz="598566" rtl="0" eaLnBrk="1" latinLnBrk="1" hangingPunct="1">
      <a:defRPr sz="786" kern="1200">
        <a:solidFill>
          <a:schemeClr val="tx1"/>
        </a:solidFill>
        <a:latin typeface="+mn-lt"/>
        <a:ea typeface="+mn-ea"/>
        <a:cs typeface="+mn-cs"/>
      </a:defRPr>
    </a:lvl5pPr>
    <a:lvl6pPr marL="1496416" algn="l" defTabSz="598566" rtl="0" eaLnBrk="1" latinLnBrk="1" hangingPunct="1">
      <a:defRPr sz="786" kern="1200">
        <a:solidFill>
          <a:schemeClr val="tx1"/>
        </a:solidFill>
        <a:latin typeface="+mn-lt"/>
        <a:ea typeface="+mn-ea"/>
        <a:cs typeface="+mn-cs"/>
      </a:defRPr>
    </a:lvl6pPr>
    <a:lvl7pPr marL="1795699" algn="l" defTabSz="598566" rtl="0" eaLnBrk="1" latinLnBrk="1" hangingPunct="1">
      <a:defRPr sz="786" kern="1200">
        <a:solidFill>
          <a:schemeClr val="tx1"/>
        </a:solidFill>
        <a:latin typeface="+mn-lt"/>
        <a:ea typeface="+mn-ea"/>
        <a:cs typeface="+mn-cs"/>
      </a:defRPr>
    </a:lvl7pPr>
    <a:lvl8pPr marL="2094982" algn="l" defTabSz="598566" rtl="0" eaLnBrk="1" latinLnBrk="1" hangingPunct="1">
      <a:defRPr sz="786" kern="1200">
        <a:solidFill>
          <a:schemeClr val="tx1"/>
        </a:solidFill>
        <a:latin typeface="+mn-lt"/>
        <a:ea typeface="+mn-ea"/>
        <a:cs typeface="+mn-cs"/>
      </a:defRPr>
    </a:lvl8pPr>
    <a:lvl9pPr marL="2394265" algn="l" defTabSz="598566" rtl="0" eaLnBrk="1" latinLnBrk="1" hangingPunct="1">
      <a:defRPr sz="786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0656" y="1237197"/>
            <a:ext cx="5447427" cy="2631887"/>
          </a:xfrm>
        </p:spPr>
        <p:txBody>
          <a:bodyPr anchor="b"/>
          <a:lstStyle>
            <a:lvl1pPr algn="ctr">
              <a:defRPr sz="4205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01092" y="3970580"/>
            <a:ext cx="4806554" cy="1825171"/>
          </a:xfrm>
        </p:spPr>
        <p:txBody>
          <a:bodyPr/>
          <a:lstStyle>
            <a:lvl1pPr marL="0" indent="0" algn="ctr">
              <a:buNone/>
              <a:defRPr sz="1682"/>
            </a:lvl1pPr>
            <a:lvl2pPr marL="320451" indent="0" algn="ctr">
              <a:buNone/>
              <a:defRPr sz="1402"/>
            </a:lvl2pPr>
            <a:lvl3pPr marL="640903" indent="0" algn="ctr">
              <a:buNone/>
              <a:defRPr sz="1262"/>
            </a:lvl3pPr>
            <a:lvl4pPr marL="961354" indent="0" algn="ctr">
              <a:buNone/>
              <a:defRPr sz="1121"/>
            </a:lvl4pPr>
            <a:lvl5pPr marL="1281806" indent="0" algn="ctr">
              <a:buNone/>
              <a:defRPr sz="1121"/>
            </a:lvl5pPr>
            <a:lvl6pPr marL="1602257" indent="0" algn="ctr">
              <a:buNone/>
              <a:defRPr sz="1121"/>
            </a:lvl6pPr>
            <a:lvl7pPr marL="1922709" indent="0" algn="ctr">
              <a:buNone/>
              <a:defRPr sz="1121"/>
            </a:lvl7pPr>
            <a:lvl8pPr marL="2243160" indent="0" algn="ctr">
              <a:buNone/>
              <a:defRPr sz="1121"/>
            </a:lvl8pPr>
            <a:lvl9pPr marL="2563612" indent="0" algn="ctr">
              <a:buNone/>
              <a:defRPr sz="1121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927BB-49FC-4D42-9A1B-9F864BA2AAE7}" type="datetimeFigureOut">
              <a:rPr lang="ko-KR" altLang="en-US" smtClean="0"/>
              <a:t>2021-02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99E90-E6D3-40A8-9B0B-4C9D4C939D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074109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927BB-49FC-4D42-9A1B-9F864BA2AAE7}" type="datetimeFigureOut">
              <a:rPr lang="ko-KR" altLang="en-US" smtClean="0"/>
              <a:t>2021-02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99E90-E6D3-40A8-9B0B-4C9D4C939D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319094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86254" y="402483"/>
            <a:ext cx="1381884" cy="640647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0601" y="402483"/>
            <a:ext cx="4065543" cy="640647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927BB-49FC-4D42-9A1B-9F864BA2AAE7}" type="datetimeFigureOut">
              <a:rPr lang="ko-KR" altLang="en-US" smtClean="0"/>
              <a:t>2021-02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99E90-E6D3-40A8-9B0B-4C9D4C939D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86258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927BB-49FC-4D42-9A1B-9F864BA2AAE7}" type="datetimeFigureOut">
              <a:rPr lang="ko-KR" altLang="en-US" smtClean="0"/>
              <a:t>2021-02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99E90-E6D3-40A8-9B0B-4C9D4C939D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660253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7263" y="1884671"/>
            <a:ext cx="5527537" cy="3144614"/>
          </a:xfrm>
        </p:spPr>
        <p:txBody>
          <a:bodyPr anchor="b"/>
          <a:lstStyle>
            <a:lvl1pPr>
              <a:defRPr sz="4205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7263" y="5059035"/>
            <a:ext cx="5527537" cy="1653678"/>
          </a:xfrm>
        </p:spPr>
        <p:txBody>
          <a:bodyPr/>
          <a:lstStyle>
            <a:lvl1pPr marL="0" indent="0">
              <a:buNone/>
              <a:defRPr sz="1682">
                <a:solidFill>
                  <a:schemeClr val="tx1"/>
                </a:solidFill>
              </a:defRPr>
            </a:lvl1pPr>
            <a:lvl2pPr marL="320451" indent="0">
              <a:buNone/>
              <a:defRPr sz="1402">
                <a:solidFill>
                  <a:schemeClr val="tx1">
                    <a:tint val="75000"/>
                  </a:schemeClr>
                </a:solidFill>
              </a:defRPr>
            </a:lvl2pPr>
            <a:lvl3pPr marL="640903" indent="0">
              <a:buNone/>
              <a:defRPr sz="1262">
                <a:solidFill>
                  <a:schemeClr val="tx1">
                    <a:tint val="75000"/>
                  </a:schemeClr>
                </a:solidFill>
              </a:defRPr>
            </a:lvl3pPr>
            <a:lvl4pPr marL="961354" indent="0">
              <a:buNone/>
              <a:defRPr sz="1121">
                <a:solidFill>
                  <a:schemeClr val="tx1">
                    <a:tint val="75000"/>
                  </a:schemeClr>
                </a:solidFill>
              </a:defRPr>
            </a:lvl4pPr>
            <a:lvl5pPr marL="1281806" indent="0">
              <a:buNone/>
              <a:defRPr sz="1121">
                <a:solidFill>
                  <a:schemeClr val="tx1">
                    <a:tint val="75000"/>
                  </a:schemeClr>
                </a:solidFill>
              </a:defRPr>
            </a:lvl5pPr>
            <a:lvl6pPr marL="1602257" indent="0">
              <a:buNone/>
              <a:defRPr sz="1121">
                <a:solidFill>
                  <a:schemeClr val="tx1">
                    <a:tint val="75000"/>
                  </a:schemeClr>
                </a:solidFill>
              </a:defRPr>
            </a:lvl6pPr>
            <a:lvl7pPr marL="1922709" indent="0">
              <a:buNone/>
              <a:defRPr sz="1121">
                <a:solidFill>
                  <a:schemeClr val="tx1">
                    <a:tint val="75000"/>
                  </a:schemeClr>
                </a:solidFill>
              </a:defRPr>
            </a:lvl7pPr>
            <a:lvl8pPr marL="2243160" indent="0">
              <a:buNone/>
              <a:defRPr sz="1121">
                <a:solidFill>
                  <a:schemeClr val="tx1">
                    <a:tint val="75000"/>
                  </a:schemeClr>
                </a:solidFill>
              </a:defRPr>
            </a:lvl8pPr>
            <a:lvl9pPr marL="2563612" indent="0">
              <a:buNone/>
              <a:defRPr sz="112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927BB-49FC-4D42-9A1B-9F864BA2AAE7}" type="datetimeFigureOut">
              <a:rPr lang="ko-KR" altLang="en-US" smtClean="0"/>
              <a:t>2021-02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99E90-E6D3-40A8-9B0B-4C9D4C939D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06757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0601" y="2012414"/>
            <a:ext cx="2723714" cy="479654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44423" y="2012414"/>
            <a:ext cx="2723714" cy="479654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927BB-49FC-4D42-9A1B-9F864BA2AAE7}" type="datetimeFigureOut">
              <a:rPr lang="ko-KR" altLang="en-US" smtClean="0"/>
              <a:t>2021-02-0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99E90-E6D3-40A8-9B0B-4C9D4C939D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903912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1435" y="402484"/>
            <a:ext cx="5527537" cy="1461188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1436" y="1853171"/>
            <a:ext cx="2711196" cy="908210"/>
          </a:xfrm>
        </p:spPr>
        <p:txBody>
          <a:bodyPr anchor="b"/>
          <a:lstStyle>
            <a:lvl1pPr marL="0" indent="0">
              <a:buNone/>
              <a:defRPr sz="1682" b="1"/>
            </a:lvl1pPr>
            <a:lvl2pPr marL="320451" indent="0">
              <a:buNone/>
              <a:defRPr sz="1402" b="1"/>
            </a:lvl2pPr>
            <a:lvl3pPr marL="640903" indent="0">
              <a:buNone/>
              <a:defRPr sz="1262" b="1"/>
            </a:lvl3pPr>
            <a:lvl4pPr marL="961354" indent="0">
              <a:buNone/>
              <a:defRPr sz="1121" b="1"/>
            </a:lvl4pPr>
            <a:lvl5pPr marL="1281806" indent="0">
              <a:buNone/>
              <a:defRPr sz="1121" b="1"/>
            </a:lvl5pPr>
            <a:lvl6pPr marL="1602257" indent="0">
              <a:buNone/>
              <a:defRPr sz="1121" b="1"/>
            </a:lvl6pPr>
            <a:lvl7pPr marL="1922709" indent="0">
              <a:buNone/>
              <a:defRPr sz="1121" b="1"/>
            </a:lvl7pPr>
            <a:lvl8pPr marL="2243160" indent="0">
              <a:buNone/>
              <a:defRPr sz="1121" b="1"/>
            </a:lvl8pPr>
            <a:lvl9pPr marL="2563612" indent="0">
              <a:buNone/>
              <a:defRPr sz="1121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1436" y="2761381"/>
            <a:ext cx="2711196" cy="406157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44424" y="1853171"/>
            <a:ext cx="2724548" cy="908210"/>
          </a:xfrm>
        </p:spPr>
        <p:txBody>
          <a:bodyPr anchor="b"/>
          <a:lstStyle>
            <a:lvl1pPr marL="0" indent="0">
              <a:buNone/>
              <a:defRPr sz="1682" b="1"/>
            </a:lvl1pPr>
            <a:lvl2pPr marL="320451" indent="0">
              <a:buNone/>
              <a:defRPr sz="1402" b="1"/>
            </a:lvl2pPr>
            <a:lvl3pPr marL="640903" indent="0">
              <a:buNone/>
              <a:defRPr sz="1262" b="1"/>
            </a:lvl3pPr>
            <a:lvl4pPr marL="961354" indent="0">
              <a:buNone/>
              <a:defRPr sz="1121" b="1"/>
            </a:lvl4pPr>
            <a:lvl5pPr marL="1281806" indent="0">
              <a:buNone/>
              <a:defRPr sz="1121" b="1"/>
            </a:lvl5pPr>
            <a:lvl6pPr marL="1602257" indent="0">
              <a:buNone/>
              <a:defRPr sz="1121" b="1"/>
            </a:lvl6pPr>
            <a:lvl7pPr marL="1922709" indent="0">
              <a:buNone/>
              <a:defRPr sz="1121" b="1"/>
            </a:lvl7pPr>
            <a:lvl8pPr marL="2243160" indent="0">
              <a:buNone/>
              <a:defRPr sz="1121" b="1"/>
            </a:lvl8pPr>
            <a:lvl9pPr marL="2563612" indent="0">
              <a:buNone/>
              <a:defRPr sz="1121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44424" y="2761381"/>
            <a:ext cx="2724548" cy="406157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927BB-49FC-4D42-9A1B-9F864BA2AAE7}" type="datetimeFigureOut">
              <a:rPr lang="ko-KR" altLang="en-US" smtClean="0"/>
              <a:t>2021-02-0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99E90-E6D3-40A8-9B0B-4C9D4C939D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696265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927BB-49FC-4D42-9A1B-9F864BA2AAE7}" type="datetimeFigureOut">
              <a:rPr lang="ko-KR" altLang="en-US" smtClean="0"/>
              <a:t>2021-02-0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99E90-E6D3-40A8-9B0B-4C9D4C939D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631999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927BB-49FC-4D42-9A1B-9F864BA2AAE7}" type="datetimeFigureOut">
              <a:rPr lang="ko-KR" altLang="en-US" smtClean="0"/>
              <a:t>2021-02-0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99E90-E6D3-40A8-9B0B-4C9D4C939D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072339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1435" y="503978"/>
            <a:ext cx="2066985" cy="1763924"/>
          </a:xfrm>
        </p:spPr>
        <p:txBody>
          <a:bodyPr anchor="b"/>
          <a:lstStyle>
            <a:lvl1pPr>
              <a:defRPr sz="2243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24548" y="1088455"/>
            <a:ext cx="3244424" cy="5372269"/>
          </a:xfrm>
        </p:spPr>
        <p:txBody>
          <a:bodyPr/>
          <a:lstStyle>
            <a:lvl1pPr>
              <a:defRPr sz="2243"/>
            </a:lvl1pPr>
            <a:lvl2pPr>
              <a:defRPr sz="1963"/>
            </a:lvl2pPr>
            <a:lvl3pPr>
              <a:defRPr sz="1682"/>
            </a:lvl3pPr>
            <a:lvl4pPr>
              <a:defRPr sz="1402"/>
            </a:lvl4pPr>
            <a:lvl5pPr>
              <a:defRPr sz="1402"/>
            </a:lvl5pPr>
            <a:lvl6pPr>
              <a:defRPr sz="1402"/>
            </a:lvl6pPr>
            <a:lvl7pPr>
              <a:defRPr sz="1402"/>
            </a:lvl7pPr>
            <a:lvl8pPr>
              <a:defRPr sz="1402"/>
            </a:lvl8pPr>
            <a:lvl9pPr>
              <a:defRPr sz="1402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1435" y="2267902"/>
            <a:ext cx="2066985" cy="4201570"/>
          </a:xfrm>
        </p:spPr>
        <p:txBody>
          <a:bodyPr/>
          <a:lstStyle>
            <a:lvl1pPr marL="0" indent="0">
              <a:buNone/>
              <a:defRPr sz="1121"/>
            </a:lvl1pPr>
            <a:lvl2pPr marL="320451" indent="0">
              <a:buNone/>
              <a:defRPr sz="981"/>
            </a:lvl2pPr>
            <a:lvl3pPr marL="640903" indent="0">
              <a:buNone/>
              <a:defRPr sz="841"/>
            </a:lvl3pPr>
            <a:lvl4pPr marL="961354" indent="0">
              <a:buNone/>
              <a:defRPr sz="701"/>
            </a:lvl4pPr>
            <a:lvl5pPr marL="1281806" indent="0">
              <a:buNone/>
              <a:defRPr sz="701"/>
            </a:lvl5pPr>
            <a:lvl6pPr marL="1602257" indent="0">
              <a:buNone/>
              <a:defRPr sz="701"/>
            </a:lvl6pPr>
            <a:lvl7pPr marL="1922709" indent="0">
              <a:buNone/>
              <a:defRPr sz="701"/>
            </a:lvl7pPr>
            <a:lvl8pPr marL="2243160" indent="0">
              <a:buNone/>
              <a:defRPr sz="701"/>
            </a:lvl8pPr>
            <a:lvl9pPr marL="2563612" indent="0">
              <a:buNone/>
              <a:defRPr sz="70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927BB-49FC-4D42-9A1B-9F864BA2AAE7}" type="datetimeFigureOut">
              <a:rPr lang="ko-KR" altLang="en-US" smtClean="0"/>
              <a:t>2021-02-0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99E90-E6D3-40A8-9B0B-4C9D4C939D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7115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1435" y="503978"/>
            <a:ext cx="2066985" cy="1763924"/>
          </a:xfrm>
        </p:spPr>
        <p:txBody>
          <a:bodyPr anchor="b"/>
          <a:lstStyle>
            <a:lvl1pPr>
              <a:defRPr sz="2243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24548" y="1088455"/>
            <a:ext cx="3244424" cy="5372269"/>
          </a:xfrm>
        </p:spPr>
        <p:txBody>
          <a:bodyPr anchor="t"/>
          <a:lstStyle>
            <a:lvl1pPr marL="0" indent="0">
              <a:buNone/>
              <a:defRPr sz="2243"/>
            </a:lvl1pPr>
            <a:lvl2pPr marL="320451" indent="0">
              <a:buNone/>
              <a:defRPr sz="1963"/>
            </a:lvl2pPr>
            <a:lvl3pPr marL="640903" indent="0">
              <a:buNone/>
              <a:defRPr sz="1682"/>
            </a:lvl3pPr>
            <a:lvl4pPr marL="961354" indent="0">
              <a:buNone/>
              <a:defRPr sz="1402"/>
            </a:lvl4pPr>
            <a:lvl5pPr marL="1281806" indent="0">
              <a:buNone/>
              <a:defRPr sz="1402"/>
            </a:lvl5pPr>
            <a:lvl6pPr marL="1602257" indent="0">
              <a:buNone/>
              <a:defRPr sz="1402"/>
            </a:lvl6pPr>
            <a:lvl7pPr marL="1922709" indent="0">
              <a:buNone/>
              <a:defRPr sz="1402"/>
            </a:lvl7pPr>
            <a:lvl8pPr marL="2243160" indent="0">
              <a:buNone/>
              <a:defRPr sz="1402"/>
            </a:lvl8pPr>
            <a:lvl9pPr marL="2563612" indent="0">
              <a:buNone/>
              <a:defRPr sz="1402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1435" y="2267902"/>
            <a:ext cx="2066985" cy="4201570"/>
          </a:xfrm>
        </p:spPr>
        <p:txBody>
          <a:bodyPr/>
          <a:lstStyle>
            <a:lvl1pPr marL="0" indent="0">
              <a:buNone/>
              <a:defRPr sz="1121"/>
            </a:lvl1pPr>
            <a:lvl2pPr marL="320451" indent="0">
              <a:buNone/>
              <a:defRPr sz="981"/>
            </a:lvl2pPr>
            <a:lvl3pPr marL="640903" indent="0">
              <a:buNone/>
              <a:defRPr sz="841"/>
            </a:lvl3pPr>
            <a:lvl4pPr marL="961354" indent="0">
              <a:buNone/>
              <a:defRPr sz="701"/>
            </a:lvl4pPr>
            <a:lvl5pPr marL="1281806" indent="0">
              <a:buNone/>
              <a:defRPr sz="701"/>
            </a:lvl5pPr>
            <a:lvl6pPr marL="1602257" indent="0">
              <a:buNone/>
              <a:defRPr sz="701"/>
            </a:lvl6pPr>
            <a:lvl7pPr marL="1922709" indent="0">
              <a:buNone/>
              <a:defRPr sz="701"/>
            </a:lvl7pPr>
            <a:lvl8pPr marL="2243160" indent="0">
              <a:buNone/>
              <a:defRPr sz="701"/>
            </a:lvl8pPr>
            <a:lvl9pPr marL="2563612" indent="0">
              <a:buNone/>
              <a:defRPr sz="70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927BB-49FC-4D42-9A1B-9F864BA2AAE7}" type="datetimeFigureOut">
              <a:rPr lang="ko-KR" altLang="en-US" smtClean="0"/>
              <a:t>2021-02-0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99E90-E6D3-40A8-9B0B-4C9D4C939D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045814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0601" y="402484"/>
            <a:ext cx="5527537" cy="14611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0601" y="2012414"/>
            <a:ext cx="5527537" cy="47965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0601" y="7006700"/>
            <a:ext cx="1441966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4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5927BB-49FC-4D42-9A1B-9F864BA2AAE7}" type="datetimeFigureOut">
              <a:rPr lang="ko-KR" altLang="en-US" smtClean="0"/>
              <a:t>2021-02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22895" y="7006700"/>
            <a:ext cx="2162949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4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26171" y="7006700"/>
            <a:ext cx="1441966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4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099E90-E6D3-40A8-9B0B-4C9D4C939D8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57059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l" defTabSz="640903" rtl="0" eaLnBrk="1" latinLnBrk="1" hangingPunct="1">
        <a:lnSpc>
          <a:spcPct val="90000"/>
        </a:lnSpc>
        <a:spcBef>
          <a:spcPct val="0"/>
        </a:spcBef>
        <a:buNone/>
        <a:defRPr sz="308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0226" indent="-160226" algn="l" defTabSz="640903" rtl="0" eaLnBrk="1" latinLnBrk="1" hangingPunct="1">
        <a:lnSpc>
          <a:spcPct val="90000"/>
        </a:lnSpc>
        <a:spcBef>
          <a:spcPts val="701"/>
        </a:spcBef>
        <a:buFont typeface="Arial" panose="020B0604020202020204" pitchFamily="34" charset="0"/>
        <a:buChar char="•"/>
        <a:defRPr sz="1963" kern="1200">
          <a:solidFill>
            <a:schemeClr val="tx1"/>
          </a:solidFill>
          <a:latin typeface="+mn-lt"/>
          <a:ea typeface="+mn-ea"/>
          <a:cs typeface="+mn-cs"/>
        </a:defRPr>
      </a:lvl1pPr>
      <a:lvl2pPr marL="480677" indent="-160226" algn="l" defTabSz="640903" rtl="0" eaLnBrk="1" latinLnBrk="1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682" kern="1200">
          <a:solidFill>
            <a:schemeClr val="tx1"/>
          </a:solidFill>
          <a:latin typeface="+mn-lt"/>
          <a:ea typeface="+mn-ea"/>
          <a:cs typeface="+mn-cs"/>
        </a:defRPr>
      </a:lvl2pPr>
      <a:lvl3pPr marL="801129" indent="-160226" algn="l" defTabSz="640903" rtl="0" eaLnBrk="1" latinLnBrk="1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402" kern="1200">
          <a:solidFill>
            <a:schemeClr val="tx1"/>
          </a:solidFill>
          <a:latin typeface="+mn-lt"/>
          <a:ea typeface="+mn-ea"/>
          <a:cs typeface="+mn-cs"/>
        </a:defRPr>
      </a:lvl3pPr>
      <a:lvl4pPr marL="1121580" indent="-160226" algn="l" defTabSz="640903" rtl="0" eaLnBrk="1" latinLnBrk="1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2" kern="1200">
          <a:solidFill>
            <a:schemeClr val="tx1"/>
          </a:solidFill>
          <a:latin typeface="+mn-lt"/>
          <a:ea typeface="+mn-ea"/>
          <a:cs typeface="+mn-cs"/>
        </a:defRPr>
      </a:lvl4pPr>
      <a:lvl5pPr marL="1442032" indent="-160226" algn="l" defTabSz="640903" rtl="0" eaLnBrk="1" latinLnBrk="1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2" kern="1200">
          <a:solidFill>
            <a:schemeClr val="tx1"/>
          </a:solidFill>
          <a:latin typeface="+mn-lt"/>
          <a:ea typeface="+mn-ea"/>
          <a:cs typeface="+mn-cs"/>
        </a:defRPr>
      </a:lvl5pPr>
      <a:lvl6pPr marL="1762483" indent="-160226" algn="l" defTabSz="640903" rtl="0" eaLnBrk="1" latinLnBrk="1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2" kern="1200">
          <a:solidFill>
            <a:schemeClr val="tx1"/>
          </a:solidFill>
          <a:latin typeface="+mn-lt"/>
          <a:ea typeface="+mn-ea"/>
          <a:cs typeface="+mn-cs"/>
        </a:defRPr>
      </a:lvl6pPr>
      <a:lvl7pPr marL="2082935" indent="-160226" algn="l" defTabSz="640903" rtl="0" eaLnBrk="1" latinLnBrk="1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2" kern="1200">
          <a:solidFill>
            <a:schemeClr val="tx1"/>
          </a:solidFill>
          <a:latin typeface="+mn-lt"/>
          <a:ea typeface="+mn-ea"/>
          <a:cs typeface="+mn-cs"/>
        </a:defRPr>
      </a:lvl7pPr>
      <a:lvl8pPr marL="2403386" indent="-160226" algn="l" defTabSz="640903" rtl="0" eaLnBrk="1" latinLnBrk="1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2" kern="1200">
          <a:solidFill>
            <a:schemeClr val="tx1"/>
          </a:solidFill>
          <a:latin typeface="+mn-lt"/>
          <a:ea typeface="+mn-ea"/>
          <a:cs typeface="+mn-cs"/>
        </a:defRPr>
      </a:lvl8pPr>
      <a:lvl9pPr marL="2723838" indent="-160226" algn="l" defTabSz="640903" rtl="0" eaLnBrk="1" latinLnBrk="1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0903" rtl="0" eaLnBrk="1" latinLnBrk="1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1pPr>
      <a:lvl2pPr marL="320451" algn="l" defTabSz="640903" rtl="0" eaLnBrk="1" latinLnBrk="1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2pPr>
      <a:lvl3pPr marL="640903" algn="l" defTabSz="640903" rtl="0" eaLnBrk="1" latinLnBrk="1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3pPr>
      <a:lvl4pPr marL="961354" algn="l" defTabSz="640903" rtl="0" eaLnBrk="1" latinLnBrk="1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4pPr>
      <a:lvl5pPr marL="1281806" algn="l" defTabSz="640903" rtl="0" eaLnBrk="1" latinLnBrk="1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5pPr>
      <a:lvl6pPr marL="1602257" algn="l" defTabSz="640903" rtl="0" eaLnBrk="1" latinLnBrk="1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6pPr>
      <a:lvl7pPr marL="1922709" algn="l" defTabSz="640903" rtl="0" eaLnBrk="1" latinLnBrk="1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7pPr>
      <a:lvl8pPr marL="2243160" algn="l" defTabSz="640903" rtl="0" eaLnBrk="1" latinLnBrk="1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8pPr>
      <a:lvl9pPr marL="2563612" algn="l" defTabSz="640903" rtl="0" eaLnBrk="1" latinLnBrk="1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4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microsoft.com/office/2007/relationships/hdphoto" Target="../media/hdphoto5.wdp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TextBox 41"/>
          <p:cNvSpPr txBox="1"/>
          <p:nvPr/>
        </p:nvSpPr>
        <p:spPr>
          <a:xfrm>
            <a:off x="303046" y="268856"/>
            <a:ext cx="149271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</a:t>
            </a:r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file </a:t>
            </a:r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: Fig. S2</a:t>
            </a:r>
            <a:endParaRPr lang="en-US" altLang="ko-KR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151265" y="733809"/>
            <a:ext cx="1524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51265" y="2162834"/>
            <a:ext cx="1524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51265" y="5171527"/>
            <a:ext cx="1524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51265" y="3566803"/>
            <a:ext cx="1524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그룹 3"/>
          <p:cNvGrpSpPr/>
          <p:nvPr/>
        </p:nvGrpSpPr>
        <p:grpSpPr>
          <a:xfrm>
            <a:off x="432877" y="2110385"/>
            <a:ext cx="5400000" cy="1555067"/>
            <a:chOff x="3132877" y="2202160"/>
            <a:chExt cx="5400000" cy="1555067"/>
          </a:xfrm>
        </p:grpSpPr>
        <p:grpSp>
          <p:nvGrpSpPr>
            <p:cNvPr id="3" name="그룹 2"/>
            <p:cNvGrpSpPr/>
            <p:nvPr/>
          </p:nvGrpSpPr>
          <p:grpSpPr>
            <a:xfrm>
              <a:off x="3132877" y="2202160"/>
              <a:ext cx="5400000" cy="1555067"/>
              <a:chOff x="3304327" y="2161538"/>
              <a:chExt cx="5400000" cy="1555067"/>
            </a:xfrm>
          </p:grpSpPr>
          <p:pic>
            <p:nvPicPr>
              <p:cNvPr id="28" name="그림 27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62685"/>
              <a:stretch/>
            </p:blipFill>
            <p:spPr>
              <a:xfrm>
                <a:off x="3304327" y="2161538"/>
                <a:ext cx="5400000" cy="628586"/>
              </a:xfrm>
              <a:prstGeom prst="rect">
                <a:avLst/>
              </a:prstGeom>
            </p:spPr>
          </p:pic>
          <p:pic>
            <p:nvPicPr>
              <p:cNvPr id="29" name="그림 28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4947"/>
              <a:stretch/>
            </p:blipFill>
            <p:spPr>
              <a:xfrm>
                <a:off x="3304327" y="2789207"/>
                <a:ext cx="5400000" cy="927398"/>
              </a:xfrm>
              <a:prstGeom prst="rect">
                <a:avLst/>
              </a:prstGeom>
            </p:spPr>
          </p:pic>
        </p:grpSp>
        <p:sp>
          <p:nvSpPr>
            <p:cNvPr id="31" name="TextBox 30"/>
            <p:cNvSpPr txBox="1"/>
            <p:nvPr/>
          </p:nvSpPr>
          <p:spPr>
            <a:xfrm>
              <a:off x="3204184" y="2274540"/>
              <a:ext cx="189112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ybpc2a</a:t>
              </a:r>
              <a:endParaRPr lang="ko-KR" altLang="en-US" sz="8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7764685" y="2913294"/>
              <a:ext cx="564118" cy="3261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7740031" y="2352515"/>
              <a:ext cx="564118" cy="3261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KO</a:t>
              </a:r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" name="그룹 4"/>
          <p:cNvGrpSpPr/>
          <p:nvPr/>
        </p:nvGrpSpPr>
        <p:grpSpPr>
          <a:xfrm>
            <a:off x="480830" y="3753182"/>
            <a:ext cx="4353161" cy="1347630"/>
            <a:chOff x="4751406" y="4133016"/>
            <a:chExt cx="4353161" cy="1347630"/>
          </a:xfrm>
        </p:grpSpPr>
        <p:pic>
          <p:nvPicPr>
            <p:cNvPr id="27" name="그림 26"/>
            <p:cNvPicPr>
              <a:picLocks noChangeAspect="1"/>
            </p:cNvPicPr>
            <p:nvPr/>
          </p:nvPicPr>
          <p:blipFill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50000"/>
                      </a14:imgEffect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51406" y="4133016"/>
              <a:ext cx="4320000" cy="1347630"/>
            </a:xfrm>
            <a:prstGeom prst="rect">
              <a:avLst/>
            </a:prstGeom>
          </p:spPr>
        </p:pic>
        <p:sp>
          <p:nvSpPr>
            <p:cNvPr id="40" name="TextBox 39"/>
            <p:cNvSpPr txBox="1"/>
            <p:nvPr/>
          </p:nvSpPr>
          <p:spPr>
            <a:xfrm>
              <a:off x="8670477" y="4604562"/>
              <a:ext cx="434090" cy="2306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8653897" y="4311139"/>
              <a:ext cx="434090" cy="2306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KO</a:t>
              </a:r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4784567" y="4200909"/>
              <a:ext cx="1455227" cy="2483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ybpc1</a:t>
              </a:r>
              <a:endParaRPr lang="ko-KR" altLang="en-US" sz="8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" name="그룹 10"/>
          <p:cNvGrpSpPr/>
          <p:nvPr/>
        </p:nvGrpSpPr>
        <p:grpSpPr>
          <a:xfrm>
            <a:off x="520501" y="5304552"/>
            <a:ext cx="4411454" cy="1347630"/>
            <a:chOff x="3016440" y="5473917"/>
            <a:chExt cx="4411454" cy="1347630"/>
          </a:xfrm>
        </p:grpSpPr>
        <p:pic>
          <p:nvPicPr>
            <p:cNvPr id="49" name="그림 48"/>
            <p:cNvPicPr>
              <a:picLocks noChangeAspect="1"/>
            </p:cNvPicPr>
            <p:nvPr/>
          </p:nvPicPr>
          <p:blipFill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50000"/>
                      </a14:imgEffect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16440" y="5473917"/>
              <a:ext cx="4320000" cy="1347630"/>
            </a:xfrm>
            <a:prstGeom prst="rect">
              <a:avLst/>
            </a:prstGeom>
          </p:spPr>
        </p:pic>
        <p:sp>
          <p:nvSpPr>
            <p:cNvPr id="33" name="TextBox 32"/>
            <p:cNvSpPr txBox="1"/>
            <p:nvPr/>
          </p:nvSpPr>
          <p:spPr>
            <a:xfrm>
              <a:off x="6937358" y="6121751"/>
              <a:ext cx="490536" cy="2735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6915920" y="5611890"/>
              <a:ext cx="490536" cy="2735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KO</a:t>
              </a:r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3086456" y="5533535"/>
              <a:ext cx="1644454" cy="2945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nnt2e</a:t>
              </a:r>
              <a:endParaRPr lang="ko-KR" altLang="en-US" sz="8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" name="그룹 11"/>
          <p:cNvGrpSpPr/>
          <p:nvPr/>
        </p:nvGrpSpPr>
        <p:grpSpPr>
          <a:xfrm>
            <a:off x="432877" y="614739"/>
            <a:ext cx="4320000" cy="1347630"/>
            <a:chOff x="4600366" y="608738"/>
            <a:chExt cx="4320000" cy="1347630"/>
          </a:xfrm>
        </p:grpSpPr>
        <p:pic>
          <p:nvPicPr>
            <p:cNvPr id="44" name="그림 43"/>
            <p:cNvPicPr>
              <a:picLocks noChangeAspect="1"/>
            </p:cNvPicPr>
            <p:nvPr/>
          </p:nvPicPr>
          <p:blipFill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sharpenSoften amount="50000"/>
                      </a14:imgEffect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00366" y="608738"/>
              <a:ext cx="4320000" cy="1347630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4658501" y="695468"/>
              <a:ext cx="1666018" cy="2867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kn1a</a:t>
              </a:r>
              <a:endParaRPr lang="ko-KR" altLang="en-US" sz="8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8367878" y="1298062"/>
              <a:ext cx="496968" cy="2663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8346159" y="760900"/>
              <a:ext cx="496968" cy="2663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KO</a:t>
              </a:r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300938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/>
          <p:cNvSpPr txBox="1"/>
          <p:nvPr/>
        </p:nvSpPr>
        <p:spPr>
          <a:xfrm>
            <a:off x="147114" y="626885"/>
            <a:ext cx="1524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47114" y="2262244"/>
            <a:ext cx="1524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176679" y="4312378"/>
            <a:ext cx="1524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" name="그림 27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3213" y="716964"/>
            <a:ext cx="4320000" cy="1347630"/>
          </a:xfrm>
          <a:prstGeom prst="rect">
            <a:avLst/>
          </a:prstGeom>
        </p:spPr>
      </p:pic>
      <p:grpSp>
        <p:nvGrpSpPr>
          <p:cNvPr id="17" name="그룹 16"/>
          <p:cNvGrpSpPr/>
          <p:nvPr/>
        </p:nvGrpSpPr>
        <p:grpSpPr>
          <a:xfrm>
            <a:off x="424078" y="2376517"/>
            <a:ext cx="5400000" cy="1684537"/>
            <a:chOff x="4938928" y="2261397"/>
            <a:chExt cx="5400000" cy="1684537"/>
          </a:xfrm>
        </p:grpSpPr>
        <p:pic>
          <p:nvPicPr>
            <p:cNvPr id="23" name="그림 22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38928" y="2261397"/>
              <a:ext cx="5400000" cy="1684537"/>
            </a:xfrm>
            <a:prstGeom prst="rect">
              <a:avLst/>
            </a:prstGeom>
          </p:spPr>
        </p:pic>
        <p:sp>
          <p:nvSpPr>
            <p:cNvPr id="24" name="TextBox 23"/>
            <p:cNvSpPr txBox="1"/>
            <p:nvPr/>
          </p:nvSpPr>
          <p:spPr>
            <a:xfrm>
              <a:off x="9228891" y="2872166"/>
              <a:ext cx="43589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9209841" y="2468638"/>
              <a:ext cx="43589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KO</a:t>
              </a:r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5037546" y="2353222"/>
              <a:ext cx="14612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nni3k</a:t>
              </a:r>
              <a:endParaRPr lang="ko-KR" altLang="en-US" sz="8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4" name="TextBox 13"/>
          <p:cNvSpPr txBox="1"/>
          <p:nvPr/>
        </p:nvSpPr>
        <p:spPr>
          <a:xfrm>
            <a:off x="4362896" y="1379371"/>
            <a:ext cx="42031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344527" y="834634"/>
            <a:ext cx="42031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KO</a:t>
            </a:r>
            <a:endParaRPr lang="ko-KR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24078" y="793023"/>
            <a:ext cx="14090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smyd1a</a:t>
            </a:r>
            <a:endParaRPr lang="ko-KR" altLang="en-US" sz="8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8" name="그룹 17"/>
          <p:cNvGrpSpPr/>
          <p:nvPr/>
        </p:nvGrpSpPr>
        <p:grpSpPr>
          <a:xfrm>
            <a:off x="374991" y="4526170"/>
            <a:ext cx="4320000" cy="1347630"/>
            <a:chOff x="374991" y="6425299"/>
            <a:chExt cx="4320000" cy="1347630"/>
          </a:xfrm>
        </p:grpSpPr>
        <p:pic>
          <p:nvPicPr>
            <p:cNvPr id="29" name="그림 28"/>
            <p:cNvPicPr>
              <a:picLocks noChangeAspect="1"/>
            </p:cNvPicPr>
            <p:nvPr/>
          </p:nvPicPr>
          <p:blipFill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50000"/>
                      </a14:imgEffect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4991" y="6425299"/>
              <a:ext cx="4320000" cy="1347630"/>
            </a:xfrm>
            <a:prstGeom prst="rect">
              <a:avLst/>
            </a:prstGeom>
          </p:spPr>
        </p:pic>
        <p:sp>
          <p:nvSpPr>
            <p:cNvPr id="30" name="TextBox 29"/>
            <p:cNvSpPr txBox="1"/>
            <p:nvPr/>
          </p:nvSpPr>
          <p:spPr>
            <a:xfrm>
              <a:off x="427192" y="6491226"/>
              <a:ext cx="1891129" cy="3512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cta1a</a:t>
              </a:r>
              <a:endParaRPr lang="ko-KR" altLang="en-US" sz="8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3886772" y="7123353"/>
              <a:ext cx="564118" cy="3261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3862114" y="6571368"/>
              <a:ext cx="564118" cy="3261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KO</a:t>
              </a:r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6777507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8329</TotalTime>
  <Words>42</Words>
  <Application>Microsoft Office PowerPoint</Application>
  <PresentationFormat>사용자 지정</PresentationFormat>
  <Paragraphs>29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Office 테마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가혜인</cp:lastModifiedBy>
  <cp:revision>1334</cp:revision>
  <cp:lastPrinted>2020-08-25T05:02:13Z</cp:lastPrinted>
  <dcterms:created xsi:type="dcterms:W3CDTF">2017-01-17T09:29:41Z</dcterms:created>
  <dcterms:modified xsi:type="dcterms:W3CDTF">2021-02-05T06:43:33Z</dcterms:modified>
</cp:coreProperties>
</file>